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60"/>
  </p:normalViewPr>
  <p:slideViewPr>
    <p:cSldViewPr>
      <p:cViewPr>
        <p:scale>
          <a:sx n="66" d="100"/>
          <a:sy n="66" d="100"/>
        </p:scale>
        <p:origin x="-2070" y="-4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6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/>
          <p:cNvPicPr preferRelativeResize="0"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2894230"/>
            <a:ext cx="3168000" cy="288000"/>
          </a:xfrm>
          <a:prstGeom prst="rect">
            <a:avLst/>
          </a:prstGeom>
        </p:spPr>
      </p:pic>
      <p:pic>
        <p:nvPicPr>
          <p:cNvPr id="25" name="图片 24"/>
          <p:cNvPicPr preferRelativeResize="0"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2147910"/>
            <a:ext cx="3168000" cy="288000"/>
          </a:xfrm>
          <a:prstGeom prst="rect">
            <a:avLst/>
          </a:prstGeom>
        </p:spPr>
      </p:pic>
      <p:pic>
        <p:nvPicPr>
          <p:cNvPr id="26" name="图片 25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2489583"/>
            <a:ext cx="3168000" cy="288000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3548959" y="2137072"/>
            <a:ext cx="11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DMP-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548959" y="2453511"/>
            <a:ext cx="11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DSPP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548959" y="2858158"/>
            <a:ext cx="11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8309387">
            <a:off x="294350" y="1560840"/>
            <a:ext cx="1118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8309387">
            <a:off x="803394" y="1456499"/>
            <a:ext cx="1373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Mimic N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8309387">
            <a:off x="1253115" y="1316228"/>
            <a:ext cx="1716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Inhibitor N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8309387">
            <a:off x="2046488" y="1606994"/>
            <a:ext cx="1005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Mimic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8309387">
            <a:off x="2644727" y="1477840"/>
            <a:ext cx="13215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Inhibitor 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1872999" y="260648"/>
            <a:ext cx="60708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The original band of  DMP-1 and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DSPP in figure-3,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5.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2" name="图片 51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8207" y="6340868"/>
            <a:ext cx="3168000" cy="288000"/>
          </a:xfrm>
          <a:prstGeom prst="rect">
            <a:avLst/>
          </a:prstGeom>
        </p:spPr>
      </p:pic>
      <p:pic>
        <p:nvPicPr>
          <p:cNvPr id="53" name="图片 52"/>
          <p:cNvPicPr preferRelativeResize="0"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8207" y="5533780"/>
            <a:ext cx="3168000" cy="288000"/>
          </a:xfrm>
          <a:prstGeom prst="rect">
            <a:avLst/>
          </a:prstGeom>
        </p:spPr>
      </p:pic>
      <p:pic>
        <p:nvPicPr>
          <p:cNvPr id="54" name="图片 53"/>
          <p:cNvPicPr preferRelativeResize="0"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98207" y="5908788"/>
            <a:ext cx="3168000" cy="288000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7219517" y="5529698"/>
            <a:ext cx="11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DMP-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219517" y="5846137"/>
            <a:ext cx="11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DSPP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219517" y="6250784"/>
            <a:ext cx="11689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8309387">
            <a:off x="3902183" y="4897874"/>
            <a:ext cx="1118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8309387">
            <a:off x="4352424" y="4795703"/>
            <a:ext cx="1373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Mimic N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8309387">
            <a:off x="4806434" y="4569008"/>
            <a:ext cx="1716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pcDNA3.1 N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8309387">
            <a:off x="5452548" y="4910003"/>
            <a:ext cx="10056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Mimic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8309387">
            <a:off x="5575318" y="4213150"/>
            <a:ext cx="2814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Mimic+pcDNA3.1-Wnt1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8309387">
            <a:off x="5910193" y="4428440"/>
            <a:ext cx="2814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pcDNA3.1-Wnt1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30032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7</TotalTime>
  <Words>35</Words>
  <Application>Microsoft Office PowerPoint</Application>
  <PresentationFormat>全屏显示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x</dc:creator>
  <cp:lastModifiedBy>yx</cp:lastModifiedBy>
  <cp:revision>49</cp:revision>
  <dcterms:created xsi:type="dcterms:W3CDTF">2018-12-02T05:33:13Z</dcterms:created>
  <dcterms:modified xsi:type="dcterms:W3CDTF">2019-06-05T11:37:56Z</dcterms:modified>
</cp:coreProperties>
</file>